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1" r:id="rId2"/>
    <p:sldId id="262" r:id="rId3"/>
    <p:sldId id="267" r:id="rId4"/>
    <p:sldId id="275" r:id="rId5"/>
    <p:sldId id="276" r:id="rId6"/>
    <p:sldId id="277" r:id="rId7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86868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7" d="100"/>
          <a:sy n="87" d="100"/>
        </p:scale>
        <p:origin x="1494" y="6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6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6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6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6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3.wdp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jpeg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4.wdp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5" Type="http://schemas.microsoft.com/office/2007/relationships/hdphoto" Target="../media/hdphoto5.wdp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6.wdp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jpeg"/><Relationship Id="rId4" Type="http://schemas.openxmlformats.org/officeDocument/2006/relationships/image" Target="../media/image8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jpeg"/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" name="Picture 35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14000" contrast="9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" r="67968"/>
          <a:stretch/>
        </p:blipFill>
        <p:spPr>
          <a:xfrm flipH="1">
            <a:off x="2438400" y="685800"/>
            <a:ext cx="3749040" cy="3063246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2559103" y="355487"/>
            <a:ext cx="199765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itchFamily="18" charset="0"/>
                <a:cs typeface="Times New Roman" pitchFamily="18" charset="0"/>
              </a:rPr>
              <a:t>C </a:t>
            </a: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  </a:t>
            </a:r>
            <a:r>
              <a:rPr lang="en-US" sz="1600" b="1" dirty="0">
                <a:latin typeface="Times New Roman" pitchFamily="18" charset="0"/>
                <a:cs typeface="Times New Roman" pitchFamily="18" charset="0"/>
              </a:rPr>
              <a:t>LPS </a:t>
            </a: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 5    10   20 </a:t>
            </a:r>
            <a:endParaRPr 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250533" y="1549795"/>
            <a:ext cx="70724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LR4</a:t>
            </a:r>
            <a:endParaRPr 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975773" y="4953000"/>
            <a:ext cx="92525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" name="Straight Connector 10"/>
          <p:cNvCxnSpPr/>
          <p:nvPr/>
        </p:nvCxnSpPr>
        <p:spPr>
          <a:xfrm>
            <a:off x="3472374" y="355487"/>
            <a:ext cx="75498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3577396" y="50687"/>
            <a:ext cx="14189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M (</a:t>
            </a:r>
            <a:r>
              <a:rPr lang="en-US" sz="1600" b="1" dirty="0" smtClean="0">
                <a:latin typeface="Symbol" panose="05050102010706020507" pitchFamily="18" charset="2"/>
                <a:cs typeface="Times New Roman" panose="02020603050405020304" pitchFamily="18" charset="0"/>
              </a:rPr>
              <a:t>m</a:t>
            </a:r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/mL) </a:t>
            </a:r>
            <a:endParaRPr 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3000" contrast="6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3052084" y="4628306"/>
            <a:ext cx="3009352" cy="2045028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6215662" y="1530039"/>
            <a:ext cx="80502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6 </a:t>
            </a:r>
            <a:r>
              <a:rPr lang="en-US" sz="1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6061436" y="4953000"/>
            <a:ext cx="80502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6 </a:t>
            </a:r>
            <a:r>
              <a:rPr lang="en-US" sz="1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211290" y="22860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8136352" y="6488668"/>
            <a:ext cx="10076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1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" name="Straight Arrow Connector 3"/>
          <p:cNvCxnSpPr/>
          <p:nvPr/>
        </p:nvCxnSpPr>
        <p:spPr>
          <a:xfrm>
            <a:off x="1981200" y="1719072"/>
            <a:ext cx="4572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>
            <a:off x="4376138" y="4330649"/>
            <a:ext cx="19976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C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LPS 5  10  20 </a:t>
            </a:r>
            <a:endParaRPr 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35" name="Straight Connector 34"/>
          <p:cNvCxnSpPr/>
          <p:nvPr/>
        </p:nvCxnSpPr>
        <p:spPr>
          <a:xfrm>
            <a:off x="4921454" y="4330649"/>
            <a:ext cx="5486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/>
          <p:cNvSpPr txBox="1"/>
          <p:nvPr/>
        </p:nvSpPr>
        <p:spPr>
          <a:xfrm>
            <a:off x="4953000" y="4066401"/>
            <a:ext cx="10695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M (</a:t>
            </a:r>
            <a:r>
              <a:rPr lang="en-US" sz="1200" b="1" dirty="0" smtClean="0">
                <a:latin typeface="Symbol" panose="05050102010706020507" pitchFamily="18" charset="2"/>
                <a:cs typeface="Times New Roman" panose="02020603050405020304" pitchFamily="18" charset="0"/>
              </a:rPr>
              <a:t>m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/mL) 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575023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TextBox 25"/>
          <p:cNvSpPr txBox="1"/>
          <p:nvPr/>
        </p:nvSpPr>
        <p:spPr>
          <a:xfrm>
            <a:off x="1770867" y="1393632"/>
            <a:ext cx="8899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X-2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1869437" y="5098349"/>
            <a:ext cx="10182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6705858" y="1393632"/>
            <a:ext cx="8835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2 </a:t>
            </a:r>
            <a:r>
              <a:rPr lang="en-US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6141892" y="5098349"/>
            <a:ext cx="8835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6 </a:t>
            </a:r>
            <a:r>
              <a:rPr lang="en-US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1" name="Picture 30"/>
          <p:cNvPicPr preferRelativeResize="0"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11000" contrast="9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1515" r="-57" b="7464"/>
          <a:stretch/>
        </p:blipFill>
        <p:spPr>
          <a:xfrm>
            <a:off x="2743200" y="757579"/>
            <a:ext cx="3840480" cy="2834640"/>
          </a:xfrm>
          <a:prstGeom prst="rect">
            <a:avLst/>
          </a:prstGeom>
        </p:spPr>
      </p:pic>
      <p:sp>
        <p:nvSpPr>
          <p:cNvPr id="37" name="TextBox 36"/>
          <p:cNvSpPr txBox="1"/>
          <p:nvPr/>
        </p:nvSpPr>
        <p:spPr>
          <a:xfrm>
            <a:off x="964276" y="4928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8153400" y="6488668"/>
            <a:ext cx="10076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363" r="7136" b="5298"/>
          <a:stretch/>
        </p:blipFill>
        <p:spPr>
          <a:xfrm>
            <a:off x="2934308" y="4295894"/>
            <a:ext cx="3108960" cy="2377440"/>
          </a:xfrm>
          <a:prstGeom prst="rect">
            <a:avLst/>
          </a:prstGeom>
        </p:spPr>
      </p:pic>
      <p:sp>
        <p:nvSpPr>
          <p:cNvPr id="36" name="TextBox 35"/>
          <p:cNvSpPr txBox="1"/>
          <p:nvPr/>
        </p:nvSpPr>
        <p:spPr>
          <a:xfrm>
            <a:off x="3048000" y="404914"/>
            <a:ext cx="199765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itchFamily="18" charset="0"/>
                <a:cs typeface="Times New Roman" pitchFamily="18" charset="0"/>
              </a:rPr>
              <a:t>C </a:t>
            </a: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LPS 5 10 20 </a:t>
            </a:r>
            <a:endParaRPr 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42" name="Straight Connector 41"/>
          <p:cNvCxnSpPr/>
          <p:nvPr/>
        </p:nvCxnSpPr>
        <p:spPr>
          <a:xfrm>
            <a:off x="3733800" y="404914"/>
            <a:ext cx="75498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/>
          <p:cNvSpPr txBox="1"/>
          <p:nvPr/>
        </p:nvSpPr>
        <p:spPr>
          <a:xfrm>
            <a:off x="3838822" y="100114"/>
            <a:ext cx="14189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M (</a:t>
            </a:r>
            <a:r>
              <a:rPr lang="en-US" sz="1600" b="1" dirty="0" smtClean="0">
                <a:latin typeface="Symbol" panose="05050102010706020507" pitchFamily="18" charset="2"/>
                <a:cs typeface="Times New Roman" panose="02020603050405020304" pitchFamily="18" charset="0"/>
              </a:rPr>
              <a:t>m</a:t>
            </a:r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/mL) </a:t>
            </a:r>
            <a:endParaRPr 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4936543" y="4078853"/>
            <a:ext cx="19976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C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LPS 5 10 20 </a:t>
            </a:r>
            <a:endParaRPr 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47" name="Straight Connector 46"/>
          <p:cNvCxnSpPr/>
          <p:nvPr/>
        </p:nvCxnSpPr>
        <p:spPr>
          <a:xfrm>
            <a:off x="5486400" y="4038600"/>
            <a:ext cx="4572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/>
          <p:cNvSpPr txBox="1"/>
          <p:nvPr/>
        </p:nvSpPr>
        <p:spPr>
          <a:xfrm>
            <a:off x="5475111" y="3801854"/>
            <a:ext cx="10695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M (</a:t>
            </a:r>
            <a:r>
              <a:rPr lang="en-US" sz="1200" b="1" dirty="0" smtClean="0">
                <a:latin typeface="Symbol" panose="05050102010706020507" pitchFamily="18" charset="2"/>
                <a:cs typeface="Times New Roman" panose="02020603050405020304" pitchFamily="18" charset="0"/>
              </a:rPr>
              <a:t>m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/mL) 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5254583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TextBox 42"/>
          <p:cNvSpPr txBox="1"/>
          <p:nvPr/>
        </p:nvSpPr>
        <p:spPr>
          <a:xfrm>
            <a:off x="8153400" y="6488668"/>
            <a:ext cx="10076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4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304800" y="34304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4554596" y="3047754"/>
            <a:ext cx="10871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 LPS HM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2376457" y="2286669"/>
            <a:ext cx="57259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L-6</a:t>
            </a:r>
            <a:endParaRPr 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5641753" y="3018813"/>
            <a:ext cx="116570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10 </a:t>
            </a:r>
            <a:r>
              <a:rPr lang="en-US" sz="1600" b="1" dirty="0" smtClean="0">
                <a:latin typeface="Symbol" panose="05050102010706020507" pitchFamily="18" charset="2"/>
                <a:cs typeface="Times New Roman" panose="02020603050405020304" pitchFamily="18" charset="0"/>
              </a:rPr>
              <a:t>m</a:t>
            </a:r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/mL)</a:t>
            </a:r>
            <a:endParaRPr 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1840701" y="4495800"/>
            <a:ext cx="107151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Symbol" panose="05050102010706020507" pitchFamily="18" charset="2"/>
                <a:cs typeface="Times New Roman" panose="02020603050405020304" pitchFamily="18" charset="0"/>
              </a:rPr>
              <a:t>a</a:t>
            </a:r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Tubulin</a:t>
            </a:r>
            <a:endParaRPr 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6113542" y="4495800"/>
            <a:ext cx="80502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5 </a:t>
            </a:r>
            <a:r>
              <a:rPr lang="en-US" sz="1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5" name="Picture 44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3000" contrast="47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1457" r="-281"/>
          <a:stretch/>
        </p:blipFill>
        <p:spPr>
          <a:xfrm>
            <a:off x="3004582" y="304800"/>
            <a:ext cx="3108960" cy="2759960"/>
          </a:xfrm>
          <a:prstGeom prst="rect">
            <a:avLst/>
          </a:prstGeom>
        </p:spPr>
      </p:pic>
      <p:sp>
        <p:nvSpPr>
          <p:cNvPr id="56" name="TextBox 55"/>
          <p:cNvSpPr txBox="1"/>
          <p:nvPr/>
        </p:nvSpPr>
        <p:spPr>
          <a:xfrm>
            <a:off x="6224605" y="2286669"/>
            <a:ext cx="80502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4 </a:t>
            </a:r>
            <a:r>
              <a:rPr lang="en-US" sz="1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2" name="Picture 51"/>
          <p:cNvPicPr preferRelativeResize="0"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2000" contrast="5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7885" t="1" r="1122" b="1132"/>
          <a:stretch/>
        </p:blipFill>
        <p:spPr>
          <a:xfrm rot="10800000">
            <a:off x="3004582" y="3750957"/>
            <a:ext cx="3054687" cy="2443749"/>
          </a:xfrm>
          <a:prstGeom prst="rect">
            <a:avLst/>
          </a:prstGeom>
        </p:spPr>
      </p:pic>
      <p:sp>
        <p:nvSpPr>
          <p:cNvPr id="44" name="TextBox 43"/>
          <p:cNvSpPr txBox="1"/>
          <p:nvPr/>
        </p:nvSpPr>
        <p:spPr>
          <a:xfrm>
            <a:off x="4551643" y="3487161"/>
            <a:ext cx="10871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 LPS HM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5641753" y="3458220"/>
            <a:ext cx="116570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10 </a:t>
            </a:r>
            <a:r>
              <a:rPr lang="en-US" sz="1600" b="1" dirty="0" smtClean="0">
                <a:latin typeface="Symbol" panose="05050102010706020507" pitchFamily="18" charset="2"/>
                <a:cs typeface="Times New Roman" panose="02020603050405020304" pitchFamily="18" charset="0"/>
              </a:rPr>
              <a:t>m</a:t>
            </a:r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/mL)</a:t>
            </a:r>
            <a:endParaRPr 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" name="Straight Connector 6"/>
          <p:cNvCxnSpPr/>
          <p:nvPr/>
        </p:nvCxnSpPr>
        <p:spPr>
          <a:xfrm>
            <a:off x="2819400" y="4690872"/>
            <a:ext cx="16665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15856476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TextBox 42"/>
          <p:cNvSpPr txBox="1"/>
          <p:nvPr/>
        </p:nvSpPr>
        <p:spPr>
          <a:xfrm>
            <a:off x="8153400" y="6488668"/>
            <a:ext cx="10076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5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1000" contrast="6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" r="48690"/>
          <a:stretch/>
        </p:blipFill>
        <p:spPr>
          <a:xfrm>
            <a:off x="2702670" y="771439"/>
            <a:ext cx="2926052" cy="2028404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649480" y="1316520"/>
            <a:ext cx="195438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phospho-p65 NF-</a:t>
            </a:r>
            <a:r>
              <a:rPr lang="en-US" sz="1600" b="1" dirty="0" smtClean="0">
                <a:latin typeface="Symbol" pitchFamily="18" charset="2"/>
                <a:cs typeface="Times New Roman" pitchFamily="18" charset="0"/>
              </a:rPr>
              <a:t>k</a:t>
            </a: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B</a:t>
            </a:r>
            <a:endParaRPr 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474603" y="3460164"/>
            <a:ext cx="11448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p65 NF-</a:t>
            </a:r>
            <a:r>
              <a:rPr lang="en-US" sz="1600" b="1" dirty="0" smtClean="0">
                <a:latin typeface="Symbol" pitchFamily="18" charset="2"/>
                <a:cs typeface="Times New Roman" pitchFamily="18" charset="0"/>
              </a:rPr>
              <a:t>k</a:t>
            </a: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B</a:t>
            </a:r>
            <a:endParaRPr 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5628721" y="1223681"/>
            <a:ext cx="80502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65 </a:t>
            </a:r>
            <a:r>
              <a:rPr lang="en-US" sz="1600" b="1" dirty="0" err="1" smtClean="0">
                <a:latin typeface="Times New Roman" pitchFamily="18" charset="0"/>
                <a:cs typeface="Times New Roman" pitchFamily="18" charset="0"/>
              </a:rPr>
              <a:t>kDa</a:t>
            </a:r>
            <a:endParaRPr 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5628721" y="3460164"/>
            <a:ext cx="80502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65 </a:t>
            </a:r>
            <a:r>
              <a:rPr lang="en-US" sz="1600" b="1" dirty="0" err="1" smtClean="0">
                <a:latin typeface="Times New Roman" pitchFamily="18" charset="0"/>
                <a:cs typeface="Times New Roman" pitchFamily="18" charset="0"/>
              </a:rPr>
              <a:t>kDa</a:t>
            </a:r>
            <a:endParaRPr 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020658" y="411769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C</a:t>
            </a:r>
            <a:endParaRPr 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200400" y="411769"/>
            <a:ext cx="55976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LPS</a:t>
            </a:r>
            <a:endParaRPr 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4486228" y="397552"/>
            <a:ext cx="147585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TAK242 (</a:t>
            </a:r>
            <a:r>
              <a:rPr lang="en-US" sz="1600" b="1" dirty="0" err="1" smtClean="0">
                <a:latin typeface="Symbol" pitchFamily="18" charset="2"/>
                <a:cs typeface="Times New Roman" pitchFamily="18" charset="0"/>
              </a:rPr>
              <a:t>m</a:t>
            </a:r>
            <a:r>
              <a:rPr lang="en-US" sz="1600" b="1" dirty="0" err="1" smtClean="0">
                <a:latin typeface="Times New Roman" pitchFamily="18" charset="0"/>
                <a:cs typeface="Times New Roman" pitchFamily="18" charset="0"/>
              </a:rPr>
              <a:t>M</a:t>
            </a: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)</a:t>
            </a:r>
            <a:endParaRPr 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3581400" y="411769"/>
            <a:ext cx="95410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 0.1  1 10</a:t>
            </a:r>
            <a:endParaRPr 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7" name="Straight Connector 16"/>
          <p:cNvCxnSpPr/>
          <p:nvPr/>
        </p:nvCxnSpPr>
        <p:spPr>
          <a:xfrm>
            <a:off x="3779520" y="411769"/>
            <a:ext cx="64008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3783631" y="76200"/>
            <a:ext cx="72808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LPS +</a:t>
            </a:r>
            <a:endParaRPr 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533400" y="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1447979" y="5696647"/>
            <a:ext cx="107151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Symbol" panose="05050102010706020507" pitchFamily="18" charset="2"/>
                <a:cs typeface="Times New Roman" panose="02020603050405020304" pitchFamily="18" charset="0"/>
              </a:rPr>
              <a:t>a</a:t>
            </a:r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Tubulin</a:t>
            </a:r>
            <a:endParaRPr 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5719036" y="5696647"/>
            <a:ext cx="80502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55 </a:t>
            </a:r>
            <a:r>
              <a:rPr lang="en-US" sz="1600" b="1" dirty="0" err="1" smtClean="0">
                <a:latin typeface="Times New Roman" pitchFamily="18" charset="0"/>
                <a:cs typeface="Times New Roman" pitchFamily="18" charset="0"/>
              </a:rPr>
              <a:t>kDa</a:t>
            </a:r>
            <a:endParaRPr 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" r="49426"/>
          <a:stretch/>
        </p:blipFill>
        <p:spPr>
          <a:xfrm flipH="1">
            <a:off x="2702670" y="2895600"/>
            <a:ext cx="2926080" cy="2011680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" r="53162" b="19868"/>
          <a:stretch/>
        </p:blipFill>
        <p:spPr>
          <a:xfrm>
            <a:off x="2499360" y="4984979"/>
            <a:ext cx="3200400" cy="20116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1199062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/>
          <p:cNvSpPr txBox="1"/>
          <p:nvPr/>
        </p:nvSpPr>
        <p:spPr>
          <a:xfrm>
            <a:off x="1524000" y="4633976"/>
            <a:ext cx="107151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Symbol" panose="05050102010706020507" pitchFamily="18" charset="2"/>
                <a:cs typeface="Times New Roman" panose="02020603050405020304" pitchFamily="18" charset="0"/>
              </a:rPr>
              <a:t>a</a:t>
            </a:r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Tubulin</a:t>
            </a:r>
            <a:endParaRPr 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1862151" y="1769477"/>
            <a:ext cx="81144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X-2</a:t>
            </a:r>
            <a:endParaRPr 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4423294" y="977299"/>
            <a:ext cx="304892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00" b="1" dirty="0" smtClean="0">
                <a:latin typeface="Times New Roman" pitchFamily="18" charset="0"/>
                <a:cs typeface="Times New Roman" pitchFamily="18" charset="0"/>
              </a:rPr>
              <a:t>C</a:t>
            </a:r>
            <a:endParaRPr lang="en-US" sz="13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4605476" y="977299"/>
            <a:ext cx="490840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00" b="1" dirty="0" smtClean="0">
                <a:latin typeface="Times New Roman" pitchFamily="18" charset="0"/>
                <a:cs typeface="Times New Roman" pitchFamily="18" charset="0"/>
              </a:rPr>
              <a:t>LPS</a:t>
            </a:r>
            <a:endParaRPr lang="en-US" sz="13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5663951" y="920354"/>
            <a:ext cx="112082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00" b="1" dirty="0" smtClean="0">
                <a:latin typeface="Times New Roman" pitchFamily="18" charset="0"/>
                <a:cs typeface="Times New Roman" pitchFamily="18" charset="0"/>
              </a:rPr>
              <a:t>NS-398</a:t>
            </a: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300" b="1" dirty="0" smtClean="0"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US" sz="1300" b="1" dirty="0" err="1" smtClean="0">
                <a:latin typeface="Symbol" pitchFamily="18" charset="2"/>
                <a:cs typeface="Times New Roman" pitchFamily="18" charset="0"/>
              </a:rPr>
              <a:t>m</a:t>
            </a:r>
            <a:r>
              <a:rPr lang="en-US" sz="1300" b="1" dirty="0" err="1" smtClean="0">
                <a:latin typeface="Times New Roman" pitchFamily="18" charset="0"/>
                <a:cs typeface="Times New Roman" pitchFamily="18" charset="0"/>
              </a:rPr>
              <a:t>M</a:t>
            </a:r>
            <a:r>
              <a:rPr lang="en-US" sz="1300" b="1" dirty="0" smtClean="0">
                <a:latin typeface="Times New Roman" pitchFamily="18" charset="0"/>
                <a:cs typeface="Times New Roman" pitchFamily="18" charset="0"/>
              </a:rPr>
              <a:t>)</a:t>
            </a:r>
            <a:endParaRPr lang="en-US" sz="13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4834362" y="968606"/>
            <a:ext cx="893193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00" b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300" b="1" dirty="0" smtClean="0">
                <a:latin typeface="Times New Roman" pitchFamily="18" charset="0"/>
                <a:cs typeface="Times New Roman" pitchFamily="18" charset="0"/>
              </a:rPr>
              <a:t>  1 10 100</a:t>
            </a:r>
            <a:endParaRPr lang="en-US" sz="130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35" name="Straight Connector 34"/>
          <p:cNvCxnSpPr/>
          <p:nvPr/>
        </p:nvCxnSpPr>
        <p:spPr>
          <a:xfrm>
            <a:off x="5053881" y="977299"/>
            <a:ext cx="5486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/>
          <p:cNvSpPr txBox="1"/>
          <p:nvPr/>
        </p:nvSpPr>
        <p:spPr>
          <a:xfrm>
            <a:off x="4992451" y="655947"/>
            <a:ext cx="72808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LPS +</a:t>
            </a:r>
            <a:endParaRPr 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5882406" y="1769477"/>
            <a:ext cx="80502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72 </a:t>
            </a:r>
            <a:r>
              <a:rPr lang="en-US" sz="1600" b="1" dirty="0" err="1" smtClean="0">
                <a:latin typeface="Times New Roman" pitchFamily="18" charset="0"/>
                <a:cs typeface="Times New Roman" pitchFamily="18" charset="0"/>
              </a:rPr>
              <a:t>kDa</a:t>
            </a:r>
            <a:endParaRPr 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5848770" y="4626882"/>
            <a:ext cx="80502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55 </a:t>
            </a:r>
            <a:r>
              <a:rPr lang="en-US" sz="1600" b="1" dirty="0" err="1" smtClean="0">
                <a:latin typeface="Times New Roman" pitchFamily="18" charset="0"/>
                <a:cs typeface="Times New Roman" pitchFamily="18" charset="0"/>
              </a:rPr>
              <a:t>kDa</a:t>
            </a:r>
            <a:endParaRPr 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1898874" y="7138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8153400" y="6488668"/>
            <a:ext cx="10076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5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990" r="466"/>
          <a:stretch/>
        </p:blipFill>
        <p:spPr>
          <a:xfrm flipH="1">
            <a:off x="2759101" y="1258908"/>
            <a:ext cx="3017520" cy="2510444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082" r="7421"/>
          <a:stretch/>
        </p:blipFill>
        <p:spPr>
          <a:xfrm flipH="1">
            <a:off x="2667661" y="3814388"/>
            <a:ext cx="3108960" cy="25104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1664708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" t="16118" r="23406" b="37546"/>
          <a:stretch/>
        </p:blipFill>
        <p:spPr>
          <a:xfrm>
            <a:off x="2286000" y="609600"/>
            <a:ext cx="4297680" cy="210312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3921750" y="76200"/>
            <a:ext cx="2443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MSO        NS-398          TAK242  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3733800" y="372720"/>
            <a:ext cx="13206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   LPS   HM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4659083" y="361703"/>
            <a:ext cx="9688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  LPS  HM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5486400" y="363048"/>
            <a:ext cx="8931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   LPS  HM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" name="Straight Connector 6"/>
          <p:cNvCxnSpPr/>
          <p:nvPr/>
        </p:nvCxnSpPr>
        <p:spPr>
          <a:xfrm>
            <a:off x="3947160" y="336023"/>
            <a:ext cx="54864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1434524" y="1374936"/>
            <a:ext cx="81144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X-2</a:t>
            </a:r>
            <a:endParaRPr 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6623715" y="1368326"/>
            <a:ext cx="80502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2 </a:t>
            </a:r>
            <a:r>
              <a:rPr lang="en-US" sz="1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6476847" y="370631"/>
            <a:ext cx="85632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10 </a:t>
            </a:r>
            <a:r>
              <a:rPr lang="en-US" sz="1100" b="1" dirty="0" smtClean="0">
                <a:latin typeface="Symbol" panose="05050102010706020507" pitchFamily="18" charset="2"/>
                <a:cs typeface="Times New Roman" panose="02020603050405020304" pitchFamily="18" charset="0"/>
              </a:rPr>
              <a:t>m</a:t>
            </a: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/mL)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609600" y="7620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" name="Straight Connector 11"/>
          <p:cNvCxnSpPr/>
          <p:nvPr/>
        </p:nvCxnSpPr>
        <p:spPr>
          <a:xfrm>
            <a:off x="4724400" y="336023"/>
            <a:ext cx="54864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>
            <a:off x="5638800" y="338428"/>
            <a:ext cx="54864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4" name="Picture 1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008" r="19682" b="17871"/>
          <a:stretch/>
        </p:blipFill>
        <p:spPr>
          <a:xfrm flipV="1">
            <a:off x="457200" y="3482816"/>
            <a:ext cx="2804176" cy="2103120"/>
          </a:xfrm>
          <a:prstGeom prst="rect">
            <a:avLst/>
          </a:prstGeom>
        </p:spPr>
      </p:pic>
      <p:sp>
        <p:nvSpPr>
          <p:cNvPr id="15" name="TextBox 14"/>
          <p:cNvSpPr txBox="1"/>
          <p:nvPr/>
        </p:nvSpPr>
        <p:spPr>
          <a:xfrm>
            <a:off x="1317585" y="2964960"/>
            <a:ext cx="20973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MSO    NS-398     TAK242  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1223419" y="3249085"/>
            <a:ext cx="13206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 LPS HM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881795" y="3251983"/>
            <a:ext cx="9688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 LPS HM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2520255" y="3254043"/>
            <a:ext cx="79701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 LPS HM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9" name="Straight Connector 18"/>
          <p:cNvCxnSpPr/>
          <p:nvPr/>
        </p:nvCxnSpPr>
        <p:spPr>
          <a:xfrm>
            <a:off x="1333155" y="3261575"/>
            <a:ext cx="54864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3214849" y="3221205"/>
            <a:ext cx="9188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10 </a:t>
            </a:r>
            <a:r>
              <a:rPr lang="en-US" sz="1200" b="1" dirty="0" smtClean="0">
                <a:latin typeface="Symbol" panose="05050102010706020507" pitchFamily="18" charset="2"/>
                <a:cs typeface="Times New Roman" panose="02020603050405020304" pitchFamily="18" charset="0"/>
              </a:rPr>
              <a:t>m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/mL)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1" name="Straight Connector 20"/>
          <p:cNvCxnSpPr/>
          <p:nvPr/>
        </p:nvCxnSpPr>
        <p:spPr>
          <a:xfrm>
            <a:off x="2011680" y="3251983"/>
            <a:ext cx="54864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>
          <a:xfrm>
            <a:off x="2644441" y="3251983"/>
            <a:ext cx="54864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3" name="Picture 22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92" t="21154" r="11727" b="24449"/>
          <a:stretch/>
        </p:blipFill>
        <p:spPr>
          <a:xfrm>
            <a:off x="4610757" y="3536281"/>
            <a:ext cx="3809980" cy="2057450"/>
          </a:xfrm>
          <a:prstGeom prst="rect">
            <a:avLst/>
          </a:prstGeom>
        </p:spPr>
      </p:pic>
      <p:sp>
        <p:nvSpPr>
          <p:cNvPr id="24" name="TextBox 23"/>
          <p:cNvSpPr txBox="1"/>
          <p:nvPr/>
        </p:nvSpPr>
        <p:spPr>
          <a:xfrm>
            <a:off x="-28575" y="4953000"/>
            <a:ext cx="57259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L-6</a:t>
            </a:r>
            <a:endParaRPr 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3213771" y="4953000"/>
            <a:ext cx="80502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4 </a:t>
            </a:r>
            <a:r>
              <a:rPr lang="en-US" sz="1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5903519" y="3001469"/>
            <a:ext cx="22511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MSO        NS-398     TAK242  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5763738" y="3277438"/>
            <a:ext cx="13206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  LPS  HM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6553200" y="3279498"/>
            <a:ext cx="9688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  LPS HM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7239000" y="3281558"/>
            <a:ext cx="8290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  LPS HM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0" name="Straight Connector 29"/>
          <p:cNvCxnSpPr/>
          <p:nvPr/>
        </p:nvCxnSpPr>
        <p:spPr>
          <a:xfrm>
            <a:off x="5928360" y="3289090"/>
            <a:ext cx="54864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/>
          <p:cNvSpPr txBox="1"/>
          <p:nvPr/>
        </p:nvSpPr>
        <p:spPr>
          <a:xfrm>
            <a:off x="7961316" y="3269380"/>
            <a:ext cx="9188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10 </a:t>
            </a:r>
            <a:r>
              <a:rPr lang="en-US" sz="1200" b="1" dirty="0" smtClean="0">
                <a:latin typeface="Symbol" panose="05050102010706020507" pitchFamily="18" charset="2"/>
                <a:cs typeface="Times New Roman" panose="02020603050405020304" pitchFamily="18" charset="0"/>
              </a:rPr>
              <a:t>m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/mL)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2" name="Straight Connector 31"/>
          <p:cNvCxnSpPr/>
          <p:nvPr/>
        </p:nvCxnSpPr>
        <p:spPr>
          <a:xfrm>
            <a:off x="6705600" y="3279498"/>
            <a:ext cx="54864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>
            <a:off x="7376160" y="3279498"/>
            <a:ext cx="54864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/>
          <p:cNvSpPr txBox="1"/>
          <p:nvPr/>
        </p:nvSpPr>
        <p:spPr>
          <a:xfrm>
            <a:off x="8415171" y="4114800"/>
            <a:ext cx="80502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5 </a:t>
            </a:r>
            <a:r>
              <a:rPr lang="en-US" sz="1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3569531" y="4086340"/>
            <a:ext cx="107151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Symbol" panose="05050102010706020507" pitchFamily="18" charset="2"/>
                <a:cs typeface="Times New Roman" panose="02020603050405020304" pitchFamily="18" charset="0"/>
              </a:rPr>
              <a:t>a</a:t>
            </a:r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Tubulin</a:t>
            </a:r>
            <a:endParaRPr 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8153400" y="6488668"/>
            <a:ext cx="10076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5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450363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476</TotalTime>
  <Words>189</Words>
  <Application>Microsoft Office PowerPoint</Application>
  <PresentationFormat>On-screen Show (4:3)</PresentationFormat>
  <Paragraphs>77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Symbol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TOU EP NASRI, SABINE VENISE  GISELE</dc:creator>
  <cp:lastModifiedBy>Sabine Venise Gisele Matou-Nasri</cp:lastModifiedBy>
  <cp:revision>258</cp:revision>
  <dcterms:created xsi:type="dcterms:W3CDTF">2006-08-16T00:00:00Z</dcterms:created>
  <dcterms:modified xsi:type="dcterms:W3CDTF">2023-06-06T06:53:57Z</dcterms:modified>
</cp:coreProperties>
</file>